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56" r:id="rId3"/>
    <p:sldId id="272" r:id="rId4"/>
    <p:sldId id="273" r:id="rId5"/>
    <p:sldId id="257" r:id="rId6"/>
    <p:sldId id="258" r:id="rId7"/>
    <p:sldId id="259" r:id="rId8"/>
    <p:sldId id="262" r:id="rId9"/>
    <p:sldId id="263" r:id="rId10"/>
    <p:sldId id="264" r:id="rId11"/>
    <p:sldId id="265" r:id="rId12"/>
    <p:sldId id="266" r:id="rId13"/>
    <p:sldId id="267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4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82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3CD45-56F6-4BD5-AA3B-5C8D3CDBB0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775BC8-58C6-46CE-9E1A-32A70737C9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B2551F-9446-4C7F-8967-25FF6C8C9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9E2DDD-CAF2-4AE5-B020-406F83228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A89816-0229-4E14-B64C-EE3F7E358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66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57FC5-2784-4A6E-858C-8B55B8E54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E4BACD-4E6B-4995-AE76-1B66269410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0379E-ADFB-41E9-87D5-624E7135F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167464-BDB1-46F8-B77E-6FA52EC73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D94C2-5E2C-4563-BAF3-DC4C41B5D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365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F076B58-E098-4714-BEB5-C5E3481AD6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720F14-BF2C-48E1-9253-5C26E75F9A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1A6934-1BCA-40CA-9478-2438293D2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3110BC-964F-4B20-BB9C-5C2B92E70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D193FC-B615-43F8-A541-1DCEBAF2A9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333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E8FE45-CDCE-4BBB-BA1B-36E310EC90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0BDB44-5DEE-43E8-8815-6EF486B7A5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0B063F-0D21-46BB-A2D8-D11BC1D19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C0DD91-1837-4F3F-8167-7811BD6F0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D7771-B869-47E9-A491-788707CE5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3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F207FE-CFA0-4A81-8B16-9C1E329FBA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A5C520-67D1-42B4-B38A-759502812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6A6F2D-3C70-49AD-AFA6-08BD1FA76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94328-86B5-4584-90D5-A147DB313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B33C8-1AD1-41D1-920F-A38C9E614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208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CB8862-7A36-45DE-B196-5D0E2BE974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ED7793-45CD-4859-92D9-F7BBB10A88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5D9C7D-0545-4815-A631-43B31FC485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BE5E9C-F54C-49DC-90C5-B2051ED0E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0DA862-EABF-4DCF-BF9F-0445FF97D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4B1B59-25DB-48AC-85C0-B1F433979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005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AFBAC-7F64-4D80-AE9F-723E02997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4850E3-6ED1-4A44-A2AA-4D0452D5FB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7F795D-2A36-4125-8E02-9A34D3838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4E64D7-D47B-4EEF-BBB8-EA645B07E6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6F1715-1F2D-44B0-9AB5-6A0F74909A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0DA326-9FD0-4177-AC30-41E919E84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59F6C2-7223-4CB7-A051-DD1220538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C1E6BD9-3F98-42E0-9360-9B09B23B0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162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6B23C-F933-4C28-B345-48EE23EBC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A940D6-67C4-4102-9DDC-578451FAA1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9C2E5F-B364-4FFA-A7B6-9BF8396DC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BDD50C-ACF5-4E15-A6FF-4AB03E5EE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899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BA94488-246D-4D13-85A9-5424647EB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CDE677-EEBE-49D9-A950-5F16F8279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C12996-EBF1-4F4F-BE47-F4B4C1E0B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91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3A9EF-2530-4EEA-9090-1266FE580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C1FA6-18B5-41DF-8CBF-8C0F790D46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CAD38C-FE5B-4683-9F52-3762A88D24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06C766-7BF8-4D98-A31A-1FBF3C5C1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C1A0D1-40ED-411D-B785-93FE2A743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D09D5F-AE56-45AF-A57F-58E3E88D2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068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798F8-40E0-49AF-A643-C704B12606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6920F0-562B-49CE-BE55-E71526CC88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5DF13E-E988-4301-AC13-5E0BC7D536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93CA46-BA07-4508-B005-5F121FACA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911694-1449-493D-A14F-C749CAD98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5B7B69-5BDE-4422-952D-B6972A8F5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249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68B32D-4D22-4F50-A9B8-AC00EB1F74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7E7797-511B-4450-AF28-692E7603B5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B9F50-B471-4617-975B-0A9CCF1DC6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1ED933-5AC4-47B4-8F43-6081EE240B01}" type="datetimeFigureOut">
              <a:rPr lang="en-US" smtClean="0"/>
              <a:t>4/2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2872D8-BD20-4284-8DBF-804D6F5DD9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B8640-B20E-45D7-8412-DA34BD966D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03261-D38C-4144-A27B-C27D5D44E4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65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lucy.stewart@usda.gov" TargetMode="Externa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microsoft.com/office/2007/relationships/hdphoto" Target="../media/hdphoto36.wdp"/><Relationship Id="rId3" Type="http://schemas.microsoft.com/office/2007/relationships/hdphoto" Target="../media/hdphoto31.wdp"/><Relationship Id="rId7" Type="http://schemas.microsoft.com/office/2007/relationships/hdphoto" Target="../media/hdphoto33.wdp"/><Relationship Id="rId12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microsoft.com/office/2007/relationships/hdphoto" Target="../media/hdphoto35.wdp"/><Relationship Id="rId5" Type="http://schemas.microsoft.com/office/2007/relationships/hdphoto" Target="../media/hdphoto32.wdp"/><Relationship Id="rId10" Type="http://schemas.openxmlformats.org/officeDocument/2006/relationships/image" Target="../media/image41.png"/><Relationship Id="rId4" Type="http://schemas.openxmlformats.org/officeDocument/2006/relationships/image" Target="../media/image38.png"/><Relationship Id="rId9" Type="http://schemas.microsoft.com/office/2007/relationships/hdphoto" Target="../media/hdphoto34.wdp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13" Type="http://schemas.microsoft.com/office/2007/relationships/hdphoto" Target="../media/hdphoto42.wdp"/><Relationship Id="rId18" Type="http://schemas.openxmlformats.org/officeDocument/2006/relationships/image" Target="../media/image51.png"/><Relationship Id="rId3" Type="http://schemas.microsoft.com/office/2007/relationships/hdphoto" Target="../media/hdphoto37.wdp"/><Relationship Id="rId7" Type="http://schemas.microsoft.com/office/2007/relationships/hdphoto" Target="../media/hdphoto39.wdp"/><Relationship Id="rId12" Type="http://schemas.openxmlformats.org/officeDocument/2006/relationships/image" Target="../media/image48.png"/><Relationship Id="rId17" Type="http://schemas.microsoft.com/office/2007/relationships/hdphoto" Target="../media/hdphoto44.wdp"/><Relationship Id="rId2" Type="http://schemas.openxmlformats.org/officeDocument/2006/relationships/image" Target="../media/image43.png"/><Relationship Id="rId16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11" Type="http://schemas.microsoft.com/office/2007/relationships/hdphoto" Target="../media/hdphoto41.wdp"/><Relationship Id="rId5" Type="http://schemas.microsoft.com/office/2007/relationships/hdphoto" Target="../media/hdphoto38.wdp"/><Relationship Id="rId15" Type="http://schemas.microsoft.com/office/2007/relationships/hdphoto" Target="../media/hdphoto43.wdp"/><Relationship Id="rId10" Type="http://schemas.openxmlformats.org/officeDocument/2006/relationships/image" Target="../media/image47.png"/><Relationship Id="rId19" Type="http://schemas.microsoft.com/office/2007/relationships/hdphoto" Target="../media/hdphoto45.wdp"/><Relationship Id="rId4" Type="http://schemas.openxmlformats.org/officeDocument/2006/relationships/image" Target="../media/image44.png"/><Relationship Id="rId9" Type="http://schemas.microsoft.com/office/2007/relationships/hdphoto" Target="../media/hdphoto40.wdp"/><Relationship Id="rId14" Type="http://schemas.openxmlformats.org/officeDocument/2006/relationships/image" Target="../media/image49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microsoft.com/office/2007/relationships/hdphoto" Target="../media/hdphoto51.wdp"/><Relationship Id="rId18" Type="http://schemas.openxmlformats.org/officeDocument/2006/relationships/image" Target="../media/image60.png"/><Relationship Id="rId3" Type="http://schemas.microsoft.com/office/2007/relationships/hdphoto" Target="../media/hdphoto46.wdp"/><Relationship Id="rId7" Type="http://schemas.microsoft.com/office/2007/relationships/hdphoto" Target="../media/hdphoto48.wdp"/><Relationship Id="rId12" Type="http://schemas.openxmlformats.org/officeDocument/2006/relationships/image" Target="../media/image57.png"/><Relationship Id="rId17" Type="http://schemas.microsoft.com/office/2007/relationships/hdphoto" Target="../media/hdphoto53.wdp"/><Relationship Id="rId2" Type="http://schemas.openxmlformats.org/officeDocument/2006/relationships/image" Target="../media/image52.png"/><Relationship Id="rId16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11" Type="http://schemas.microsoft.com/office/2007/relationships/hdphoto" Target="../media/hdphoto50.wdp"/><Relationship Id="rId5" Type="http://schemas.microsoft.com/office/2007/relationships/hdphoto" Target="../media/hdphoto47.wdp"/><Relationship Id="rId15" Type="http://schemas.microsoft.com/office/2007/relationships/hdphoto" Target="../media/hdphoto52.wdp"/><Relationship Id="rId10" Type="http://schemas.openxmlformats.org/officeDocument/2006/relationships/image" Target="../media/image56.png"/><Relationship Id="rId19" Type="http://schemas.microsoft.com/office/2007/relationships/hdphoto" Target="../media/hdphoto54.wdp"/><Relationship Id="rId4" Type="http://schemas.openxmlformats.org/officeDocument/2006/relationships/image" Target="../media/image53.png"/><Relationship Id="rId9" Type="http://schemas.microsoft.com/office/2007/relationships/hdphoto" Target="../media/hdphoto49.wdp"/><Relationship Id="rId14" Type="http://schemas.openxmlformats.org/officeDocument/2006/relationships/image" Target="../media/image58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13" Type="http://schemas.microsoft.com/office/2007/relationships/hdphoto" Target="../media/hdphoto60.wdp"/><Relationship Id="rId18" Type="http://schemas.openxmlformats.org/officeDocument/2006/relationships/image" Target="../media/image69.png"/><Relationship Id="rId3" Type="http://schemas.microsoft.com/office/2007/relationships/hdphoto" Target="../media/hdphoto55.wdp"/><Relationship Id="rId7" Type="http://schemas.microsoft.com/office/2007/relationships/hdphoto" Target="../media/hdphoto57.wdp"/><Relationship Id="rId12" Type="http://schemas.openxmlformats.org/officeDocument/2006/relationships/image" Target="../media/image66.png"/><Relationship Id="rId17" Type="http://schemas.microsoft.com/office/2007/relationships/hdphoto" Target="../media/hdphoto62.wdp"/><Relationship Id="rId2" Type="http://schemas.openxmlformats.org/officeDocument/2006/relationships/image" Target="../media/image61.png"/><Relationship Id="rId16" Type="http://schemas.openxmlformats.org/officeDocument/2006/relationships/image" Target="../media/image6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11" Type="http://schemas.microsoft.com/office/2007/relationships/hdphoto" Target="../media/hdphoto59.wdp"/><Relationship Id="rId5" Type="http://schemas.microsoft.com/office/2007/relationships/hdphoto" Target="../media/hdphoto56.wdp"/><Relationship Id="rId15" Type="http://schemas.microsoft.com/office/2007/relationships/hdphoto" Target="../media/hdphoto61.wdp"/><Relationship Id="rId10" Type="http://schemas.openxmlformats.org/officeDocument/2006/relationships/image" Target="../media/image65.png"/><Relationship Id="rId19" Type="http://schemas.microsoft.com/office/2007/relationships/hdphoto" Target="../media/hdphoto63.wdp"/><Relationship Id="rId4" Type="http://schemas.openxmlformats.org/officeDocument/2006/relationships/image" Target="../media/image62.png"/><Relationship Id="rId9" Type="http://schemas.microsoft.com/office/2007/relationships/hdphoto" Target="../media/hdphoto58.wdp"/><Relationship Id="rId14" Type="http://schemas.openxmlformats.org/officeDocument/2006/relationships/image" Target="../media/image6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4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2.wdp"/><Relationship Id="rId3" Type="http://schemas.microsoft.com/office/2007/relationships/hdphoto" Target="../media/hdphoto7.wdp"/><Relationship Id="rId7" Type="http://schemas.microsoft.com/office/2007/relationships/hdphoto" Target="../media/hdphoto9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microsoft.com/office/2007/relationships/hdphoto" Target="../media/hdphoto11.wdp"/><Relationship Id="rId5" Type="http://schemas.microsoft.com/office/2007/relationships/hdphoto" Target="../media/hdphoto8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10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microsoft.com/office/2007/relationships/hdphoto" Target="../media/hdphoto18.wdp"/><Relationship Id="rId3" Type="http://schemas.microsoft.com/office/2007/relationships/hdphoto" Target="../media/hdphoto13.wdp"/><Relationship Id="rId7" Type="http://schemas.microsoft.com/office/2007/relationships/hdphoto" Target="../media/hdphoto15.wdp"/><Relationship Id="rId12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11" Type="http://schemas.microsoft.com/office/2007/relationships/hdphoto" Target="../media/hdphoto17.wdp"/><Relationship Id="rId5" Type="http://schemas.microsoft.com/office/2007/relationships/hdphoto" Target="../media/hdphoto14.wdp"/><Relationship Id="rId10" Type="http://schemas.openxmlformats.org/officeDocument/2006/relationships/image" Target="../media/image23.png"/><Relationship Id="rId4" Type="http://schemas.openxmlformats.org/officeDocument/2006/relationships/image" Target="../media/image20.png"/><Relationship Id="rId9" Type="http://schemas.microsoft.com/office/2007/relationships/hdphoto" Target="../media/hdphoto16.wdp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microsoft.com/office/2007/relationships/hdphoto" Target="../media/hdphoto24.wdp"/><Relationship Id="rId3" Type="http://schemas.microsoft.com/office/2007/relationships/hdphoto" Target="../media/hdphoto19.wdp"/><Relationship Id="rId7" Type="http://schemas.microsoft.com/office/2007/relationships/hdphoto" Target="../media/hdphoto21.wdp"/><Relationship Id="rId12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png"/><Relationship Id="rId11" Type="http://schemas.microsoft.com/office/2007/relationships/hdphoto" Target="../media/hdphoto23.wdp"/><Relationship Id="rId5" Type="http://schemas.microsoft.com/office/2007/relationships/hdphoto" Target="../media/hdphoto20.wdp"/><Relationship Id="rId10" Type="http://schemas.openxmlformats.org/officeDocument/2006/relationships/image" Target="../media/image29.png"/><Relationship Id="rId4" Type="http://schemas.openxmlformats.org/officeDocument/2006/relationships/image" Target="../media/image26.png"/><Relationship Id="rId9" Type="http://schemas.microsoft.com/office/2007/relationships/hdphoto" Target="../media/hdphoto22.wdp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microsoft.com/office/2007/relationships/hdphoto" Target="../media/hdphoto30.wdp"/><Relationship Id="rId3" Type="http://schemas.microsoft.com/office/2007/relationships/hdphoto" Target="../media/hdphoto25.wdp"/><Relationship Id="rId7" Type="http://schemas.microsoft.com/office/2007/relationships/hdphoto" Target="../media/hdphoto27.wdp"/><Relationship Id="rId12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microsoft.com/office/2007/relationships/hdphoto" Target="../media/hdphoto29.wdp"/><Relationship Id="rId5" Type="http://schemas.microsoft.com/office/2007/relationships/hdphoto" Target="../media/hdphoto26.wdp"/><Relationship Id="rId10" Type="http://schemas.openxmlformats.org/officeDocument/2006/relationships/image" Target="../media/image35.png"/><Relationship Id="rId4" Type="http://schemas.openxmlformats.org/officeDocument/2006/relationships/image" Target="../media/image32.png"/><Relationship Id="rId9" Type="http://schemas.microsoft.com/office/2007/relationships/hdphoto" Target="../media/hdphoto28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9D2B914-3F12-437B-803C-2B0DC646884F}"/>
              </a:ext>
            </a:extLst>
          </p:cNvPr>
          <p:cNvSpPr/>
          <p:nvPr/>
        </p:nvSpPr>
        <p:spPr>
          <a:xfrm>
            <a:off x="3726473" y="827212"/>
            <a:ext cx="4739054" cy="4723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imultaneous gene expression and multi-gene silencing in </a:t>
            </a:r>
            <a:r>
              <a:rPr lang="en-US" sz="16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Zea</a:t>
            </a:r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ys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sing maize dwarf mosaic virus </a:t>
            </a:r>
          </a:p>
          <a:p>
            <a:pPr algn="just">
              <a:lnSpc>
                <a:spcPct val="200000"/>
              </a:lnSpc>
            </a:pP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nshuang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Xie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†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eMarie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arty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†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unhua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Xu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tika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Khatri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Kristen Willie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nderso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ucker Moraes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Lucy R. Stewart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,1*</a:t>
            </a:r>
          </a:p>
          <a:p>
            <a:pPr algn="just">
              <a:lnSpc>
                <a:spcPct val="200000"/>
              </a:lnSpc>
            </a:pP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Plant Pathology, the Ohio State University, Wooster, OH 44691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DA-ARS Corn Soybean and Wheat Quality Research Unit, Wooster, OH 44691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0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†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se authors contributed equally to this work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</a:t>
            </a:r>
            <a:r>
              <a:rPr lang="en-US" sz="1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lucy.stewart@usda.gov</a:t>
            </a:r>
            <a:endParaRPr lang="en-US" sz="1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8930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7EA9A-0B0C-4EC1-986E-75C5847278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0065" y="13994"/>
            <a:ext cx="3607191" cy="1256029"/>
          </a:xfrm>
        </p:spPr>
        <p:txBody>
          <a:bodyPr>
            <a:normAutofit/>
          </a:bodyPr>
          <a:lstStyle/>
          <a:p>
            <a:r>
              <a:rPr lang="en-US" sz="4000" dirty="0"/>
              <a:t>pWX68- Rep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8509B2E-EF7B-47B1-83E9-B3BD9723D4B8}"/>
              </a:ext>
            </a:extLst>
          </p:cNvPr>
          <p:cNvSpPr txBox="1"/>
          <p:nvPr/>
        </p:nvSpPr>
        <p:spPr>
          <a:xfrm>
            <a:off x="981143" y="1270023"/>
            <a:ext cx="953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 Day 7                                                                Day 14                                                            Day 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2E6474-38CD-4402-A9DF-984ED80B1418}"/>
              </a:ext>
            </a:extLst>
          </p:cNvPr>
          <p:cNvSpPr txBox="1"/>
          <p:nvPr/>
        </p:nvSpPr>
        <p:spPr>
          <a:xfrm>
            <a:off x="107122" y="3814468"/>
            <a:ext cx="2708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4 (505bp)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3EC04C35-8424-49B6-BA50-6E27AD6ACF30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1970920"/>
            <a:ext cx="3566160" cy="16459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FCE48F3-2AB3-4A0F-8F9E-81CCFC557418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4129667"/>
            <a:ext cx="3566160" cy="16459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27F5ECB-2AD8-4380-9B6E-346F5EDA8F55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1970920"/>
            <a:ext cx="3566160" cy="164592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8751D27-7DB3-4B2E-8EF3-057F7DB7FF17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4122245"/>
            <a:ext cx="3566160" cy="164592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F0D84D7-5802-43AA-A984-C6B2C5CDF115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1970920"/>
            <a:ext cx="3566160" cy="164592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3007FBF-A1A4-4888-B8FD-75C56929697B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4122245"/>
            <a:ext cx="3566160" cy="16459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F5CEFB4-5C1F-428A-BE21-331ECD95A56C}"/>
              </a:ext>
            </a:extLst>
          </p:cNvPr>
          <p:cNvSpPr txBox="1"/>
          <p:nvPr/>
        </p:nvSpPr>
        <p:spPr>
          <a:xfrm>
            <a:off x="107122" y="1663143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0F0ABA-74D7-4099-A174-431B8D482F3C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10950448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C988C-72B6-4A53-B1DF-A57FB88F4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0961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56- Rep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A9AFB9-080C-4969-9C28-B3203ECF5856}"/>
              </a:ext>
            </a:extLst>
          </p:cNvPr>
          <p:cNvSpPr txBox="1"/>
          <p:nvPr/>
        </p:nvSpPr>
        <p:spPr>
          <a:xfrm>
            <a:off x="1020417" y="1240517"/>
            <a:ext cx="9427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Day 7                                                              Day 14                                                         Day 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514C17-4512-4EB3-BC69-E07F3897E13A}"/>
              </a:ext>
            </a:extLst>
          </p:cNvPr>
          <p:cNvSpPr txBox="1"/>
          <p:nvPr/>
        </p:nvSpPr>
        <p:spPr>
          <a:xfrm>
            <a:off x="89858" y="1527883"/>
            <a:ext cx="2759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27/WX315 (413bp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CC4165-DA57-4372-A9E8-FF67944E4E9F}"/>
              </a:ext>
            </a:extLst>
          </p:cNvPr>
          <p:cNvSpPr txBox="1"/>
          <p:nvPr/>
        </p:nvSpPr>
        <p:spPr>
          <a:xfrm>
            <a:off x="85851" y="3227127"/>
            <a:ext cx="28000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3B754E-A52C-496A-8F13-B7EA701C9828}"/>
              </a:ext>
            </a:extLst>
          </p:cNvPr>
          <p:cNvSpPr txBox="1"/>
          <p:nvPr/>
        </p:nvSpPr>
        <p:spPr>
          <a:xfrm>
            <a:off x="85851" y="4897466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58/WX367 (1115bp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CA9DFA5-1872-45FC-8225-D301E4A842BC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9056" y="1835660"/>
            <a:ext cx="3657600" cy="13716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D7C4AA4C-2DEB-430E-8070-F3C8784098D6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9056" y="3514101"/>
            <a:ext cx="3657600" cy="13716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7B12D9E-0522-4566-A1CC-4DAB263B155A}"/>
              </a:ext>
            </a:extLst>
          </p:cNvPr>
          <p:cNvPicPr>
            <a:picLocks/>
          </p:cNvPicPr>
          <p:nvPr/>
        </p:nvPicPr>
        <p:blipFill rotWithShape="1"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9056" y="5192543"/>
            <a:ext cx="3657600" cy="13716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510ED61-04C7-4C18-8635-9F65FD79FF64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62036" y="3526399"/>
            <a:ext cx="3657600" cy="13716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455AF6B-E652-4DC3-B831-31FC5437AE50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62036" y="1860256"/>
            <a:ext cx="3657600" cy="13716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8B5D66D-36A3-417E-A690-984871369441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62036" y="5192543"/>
            <a:ext cx="3657600" cy="13716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D0D7BAF-4423-42BA-AE6F-6EC7BBDE033A}"/>
              </a:ext>
            </a:extLst>
          </p:cNvPr>
          <p:cNvPicPr>
            <a:picLocks/>
          </p:cNvPicPr>
          <p:nvPr/>
        </p:nvPicPr>
        <p:blipFill rotWithShape="1">
          <a:blip r:embed="rId14" cstate="screen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95015" y="5192543"/>
            <a:ext cx="3657600" cy="13716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631A3AB-8BF9-4D18-AAEB-632C9080AEC9}"/>
              </a:ext>
            </a:extLst>
          </p:cNvPr>
          <p:cNvPicPr>
            <a:picLocks/>
          </p:cNvPicPr>
          <p:nvPr/>
        </p:nvPicPr>
        <p:blipFill rotWithShape="1">
          <a:blip r:embed="rId16" cstate="screen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95015" y="3526399"/>
            <a:ext cx="3657600" cy="13716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F914970-862B-410B-B4F7-FF89B5B4F443}"/>
              </a:ext>
            </a:extLst>
          </p:cNvPr>
          <p:cNvPicPr>
            <a:picLocks/>
          </p:cNvPicPr>
          <p:nvPr/>
        </p:nvPicPr>
        <p:blipFill rotWithShape="1">
          <a:blip r:embed="rId18" cstate="screen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95015" y="1860256"/>
            <a:ext cx="3657600" cy="13716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6A2211A5-FA3E-470D-B715-FEE0F654A3B5}"/>
              </a:ext>
            </a:extLst>
          </p:cNvPr>
          <p:cNvSpPr txBox="1"/>
          <p:nvPr/>
        </p:nvSpPr>
        <p:spPr>
          <a:xfrm>
            <a:off x="1345285" y="6501653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33019835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>
            <a:extLst>
              <a:ext uri="{FF2B5EF4-FFF2-40B4-BE49-F238E27FC236}">
                <a16:creationId xmlns:a16="http://schemas.microsoft.com/office/drawing/2014/main" id="{4C71903C-82DB-4C56-82A2-796BF6A13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0961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56- Rep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B08E671-AD03-4CA8-BC39-C8325C984D79}"/>
              </a:ext>
            </a:extLst>
          </p:cNvPr>
          <p:cNvSpPr txBox="1"/>
          <p:nvPr/>
        </p:nvSpPr>
        <p:spPr>
          <a:xfrm>
            <a:off x="1020417" y="1031194"/>
            <a:ext cx="9745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Day 7                                                                 Day 14                                                             Day 2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B5C90A67-A8FF-43E0-9242-7C47CBB4B865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800" y="3330386"/>
            <a:ext cx="3657600" cy="13716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14A4671-6F91-4FA7-8694-DA87CD550017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800" y="5057195"/>
            <a:ext cx="3657600" cy="13716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DDCD7A2B-4B10-4C20-826F-93DE1E29B344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04800" y="1603578"/>
            <a:ext cx="3657600" cy="13716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0F3CD79-9341-4193-9B58-8328DD0A2A02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67200" y="1617889"/>
            <a:ext cx="3657600" cy="13716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B7C6308-67C8-4EF9-B876-3E46E5E612BF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67200" y="5057195"/>
            <a:ext cx="3657600" cy="13716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2CCDB6B-D2E2-4F19-ADB5-4CEF906F8128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267200" y="3330386"/>
            <a:ext cx="3657600" cy="13716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F3B7102-81F6-40ED-93B8-0D19B5F4B265}"/>
              </a:ext>
            </a:extLst>
          </p:cNvPr>
          <p:cNvPicPr>
            <a:picLocks/>
          </p:cNvPicPr>
          <p:nvPr/>
        </p:nvPicPr>
        <p:blipFill rotWithShape="1">
          <a:blip r:embed="rId14" cstate="screen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29600" y="5033674"/>
            <a:ext cx="3657600" cy="13716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667C20D-16D6-4D3A-A137-0D2127D330C0}"/>
              </a:ext>
            </a:extLst>
          </p:cNvPr>
          <p:cNvPicPr>
            <a:picLocks/>
          </p:cNvPicPr>
          <p:nvPr/>
        </p:nvPicPr>
        <p:blipFill rotWithShape="1">
          <a:blip r:embed="rId16" cstate="screen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29600" y="3316537"/>
            <a:ext cx="3657600" cy="13716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CC63767F-AB01-4407-9A26-2AB7A5B4FCC5}"/>
              </a:ext>
            </a:extLst>
          </p:cNvPr>
          <p:cNvPicPr>
            <a:picLocks/>
          </p:cNvPicPr>
          <p:nvPr/>
        </p:nvPicPr>
        <p:blipFill rotWithShape="1">
          <a:blip r:embed="rId18" cstate="screen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29600" y="1640494"/>
            <a:ext cx="3657600" cy="13716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82A864BD-ED40-45F7-86EC-579E0F01C8F8}"/>
              </a:ext>
            </a:extLst>
          </p:cNvPr>
          <p:cNvSpPr txBox="1"/>
          <p:nvPr/>
        </p:nvSpPr>
        <p:spPr>
          <a:xfrm>
            <a:off x="146117" y="1318560"/>
            <a:ext cx="2759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27/WX315 (413bp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B13A437-4552-4F4E-A912-E6A70F4F7CC0}"/>
              </a:ext>
            </a:extLst>
          </p:cNvPr>
          <p:cNvSpPr txBox="1"/>
          <p:nvPr/>
        </p:nvSpPr>
        <p:spPr>
          <a:xfrm>
            <a:off x="142110" y="3017804"/>
            <a:ext cx="28000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21F98CD-3475-4AD2-91BD-4ADBAA82432F}"/>
              </a:ext>
            </a:extLst>
          </p:cNvPr>
          <p:cNvSpPr txBox="1"/>
          <p:nvPr/>
        </p:nvSpPr>
        <p:spPr>
          <a:xfrm>
            <a:off x="142110" y="4688143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58/WX367 (1115bp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7714CA-411F-4F2E-979D-F8004A78863F}"/>
              </a:ext>
            </a:extLst>
          </p:cNvPr>
          <p:cNvSpPr txBox="1"/>
          <p:nvPr/>
        </p:nvSpPr>
        <p:spPr>
          <a:xfrm>
            <a:off x="1373429" y="6405274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1442018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>
            <a:extLst>
              <a:ext uri="{FF2B5EF4-FFF2-40B4-BE49-F238E27FC236}">
                <a16:creationId xmlns:a16="http://schemas.microsoft.com/office/drawing/2014/main" id="{52B0D5E2-5A76-4F4A-9F37-312424C4D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0961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56- Rep 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23C2DBF-55D7-4E21-B8B4-AC7687A8D943}"/>
              </a:ext>
            </a:extLst>
          </p:cNvPr>
          <p:cNvSpPr txBox="1"/>
          <p:nvPr/>
        </p:nvSpPr>
        <p:spPr>
          <a:xfrm>
            <a:off x="1020417" y="1240517"/>
            <a:ext cx="926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    Day 7                                                           Day 14                                                         Day 2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3654719B-F09B-4A5F-A1CF-978BC17B0843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887" y="5183919"/>
            <a:ext cx="3657600" cy="137160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CE7F414B-BABA-4F7C-85A6-68B9C08DA6E4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887" y="3498688"/>
            <a:ext cx="3657600" cy="137160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C076630-3E78-4A2A-94F2-D2385CCD393C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887" y="1813457"/>
            <a:ext cx="3657600" cy="137160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F65BEA8-7211-4FDC-9EE8-4AA49570833C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09869" y="1817192"/>
            <a:ext cx="3657600" cy="13716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00EA8A42-9F2C-4B22-AEB6-A4770BE6DBCE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1812" y="5166293"/>
            <a:ext cx="3657600" cy="137160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0D251AC-B46F-439C-ABE5-F0965F851140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09869" y="3491743"/>
            <a:ext cx="3657600" cy="13716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6FB3F2B-81F0-4969-919F-19FD3AF2F4C3}"/>
              </a:ext>
            </a:extLst>
          </p:cNvPr>
          <p:cNvPicPr>
            <a:picLocks/>
          </p:cNvPicPr>
          <p:nvPr/>
        </p:nvPicPr>
        <p:blipFill rotWithShape="1">
          <a:blip r:embed="rId14" cstate="screen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35738" y="5183919"/>
            <a:ext cx="3657600" cy="137160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93BD2DC-B84A-4476-A33D-D266D651335A}"/>
              </a:ext>
            </a:extLst>
          </p:cNvPr>
          <p:cNvPicPr>
            <a:picLocks/>
          </p:cNvPicPr>
          <p:nvPr/>
        </p:nvPicPr>
        <p:blipFill rotWithShape="1">
          <a:blip r:embed="rId16" cstate="screen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31851" y="3498688"/>
            <a:ext cx="3657600" cy="13716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4616834-2678-49DE-8A92-B821103CF0B8}"/>
              </a:ext>
            </a:extLst>
          </p:cNvPr>
          <p:cNvPicPr>
            <a:picLocks/>
          </p:cNvPicPr>
          <p:nvPr/>
        </p:nvPicPr>
        <p:blipFill rotWithShape="1">
          <a:blip r:embed="rId18" cstate="screen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131851" y="1813457"/>
            <a:ext cx="3657600" cy="13716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47A344A3-F168-429F-BB75-E5B90B585D4F}"/>
              </a:ext>
            </a:extLst>
          </p:cNvPr>
          <p:cNvSpPr txBox="1"/>
          <p:nvPr/>
        </p:nvSpPr>
        <p:spPr>
          <a:xfrm>
            <a:off x="89858" y="1527883"/>
            <a:ext cx="2759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27/WX315 (413bp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0FF59F-4D09-46D0-82A0-AD8365843BFE}"/>
              </a:ext>
            </a:extLst>
          </p:cNvPr>
          <p:cNvSpPr txBox="1"/>
          <p:nvPr/>
        </p:nvSpPr>
        <p:spPr>
          <a:xfrm>
            <a:off x="85851" y="3227127"/>
            <a:ext cx="28000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A095FFD-4031-4598-BAEE-CF2F1D4659C2}"/>
              </a:ext>
            </a:extLst>
          </p:cNvPr>
          <p:cNvSpPr txBox="1"/>
          <p:nvPr/>
        </p:nvSpPr>
        <p:spPr>
          <a:xfrm>
            <a:off x="85851" y="4897466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58/WX367 (1115bp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B65938A-311C-47D0-8E6E-DC490ADFA08F}"/>
              </a:ext>
            </a:extLst>
          </p:cNvPr>
          <p:cNvSpPr txBox="1"/>
          <p:nvPr/>
        </p:nvSpPr>
        <p:spPr>
          <a:xfrm>
            <a:off x="1404116" y="6555519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4280235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CECB576A-7C94-6744-9CE4-E025643B4275}"/>
              </a:ext>
            </a:extLst>
          </p:cNvPr>
          <p:cNvSpPr txBox="1">
            <a:spLocks/>
          </p:cNvSpPr>
          <p:nvPr/>
        </p:nvSpPr>
        <p:spPr>
          <a:xfrm>
            <a:off x="3803594" y="1288973"/>
            <a:ext cx="4249736" cy="4461831"/>
          </a:xfrm>
          <a:prstGeom prst="rect">
            <a:avLst/>
          </a:prstGeom>
        </p:spPr>
        <p:txBody>
          <a:bodyPr>
            <a:normAutofit fontScale="97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:</a:t>
            </a:r>
          </a:p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gel and blot images for Figure 3.</a:t>
            </a:r>
          </a:p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 gel images for  Additional File 2: Figure S2</a:t>
            </a:r>
          </a:p>
        </p:txBody>
      </p:sp>
    </p:spTree>
    <p:extLst>
      <p:ext uri="{BB962C8B-B14F-4D97-AF65-F5344CB8AC3E}">
        <p14:creationId xmlns:p14="http://schemas.microsoft.com/office/powerpoint/2010/main" val="2498494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74CE4D9E-C8AD-4AC0-B27C-03BACD4D927C}"/>
              </a:ext>
            </a:extLst>
          </p:cNvPr>
          <p:cNvSpPr txBox="1"/>
          <p:nvPr/>
        </p:nvSpPr>
        <p:spPr>
          <a:xfrm rot="18720000">
            <a:off x="10878444" y="1564176"/>
            <a:ext cx="1219077" cy="1580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rotein standard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A891AA7-43BD-4AA3-A865-F3852AEC1B30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Coomassie blue- stained gel images for Fig. 3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C70243D3-7F79-4FAF-A7FE-592EEBE3583F}"/>
              </a:ext>
            </a:extLst>
          </p:cNvPr>
          <p:cNvGrpSpPr/>
          <p:nvPr/>
        </p:nvGrpSpPr>
        <p:grpSpPr>
          <a:xfrm>
            <a:off x="838200" y="1088432"/>
            <a:ext cx="10667352" cy="4425226"/>
            <a:chOff x="838200" y="1088432"/>
            <a:chExt cx="10667352" cy="4425226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9FCDEAAF-3B8B-4BFF-AA1F-39472E5DE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4191" y="2248441"/>
              <a:ext cx="2574967" cy="2579231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582EC75-B5FE-4881-B816-C1E94D918C1A}"/>
                </a:ext>
              </a:extLst>
            </p:cNvPr>
            <p:cNvSpPr txBox="1"/>
            <p:nvPr/>
          </p:nvSpPr>
          <p:spPr>
            <a:xfrm rot="18720000">
              <a:off x="2754219" y="1792485"/>
              <a:ext cx="88233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5 ng 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68B250F-7757-4E5D-888C-63A21DA062A6}"/>
                </a:ext>
              </a:extLst>
            </p:cNvPr>
            <p:cNvSpPr txBox="1"/>
            <p:nvPr/>
          </p:nvSpPr>
          <p:spPr>
            <a:xfrm rot="18720000">
              <a:off x="1092624" y="1733279"/>
              <a:ext cx="1172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2869CFE-3BC9-4288-86BC-E492C7E592BE}"/>
                </a:ext>
              </a:extLst>
            </p:cNvPr>
            <p:cNvSpPr txBox="1"/>
            <p:nvPr/>
          </p:nvSpPr>
          <p:spPr>
            <a:xfrm rot="18720000">
              <a:off x="1566853" y="1806285"/>
              <a:ext cx="975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8FD6A0F-3D04-435E-AD5E-7A9312617BB2}"/>
                </a:ext>
              </a:extLst>
            </p:cNvPr>
            <p:cNvSpPr txBox="1"/>
            <p:nvPr/>
          </p:nvSpPr>
          <p:spPr>
            <a:xfrm rot="18720000">
              <a:off x="1340372" y="1791146"/>
              <a:ext cx="975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D80D9ECA-FCC5-483F-8AF1-22DE9C0C4A6B}"/>
                </a:ext>
              </a:extLst>
            </p:cNvPr>
            <p:cNvSpPr/>
            <p:nvPr/>
          </p:nvSpPr>
          <p:spPr>
            <a:xfrm>
              <a:off x="889923" y="2241048"/>
              <a:ext cx="372986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 err="1"/>
                <a:t>kD</a:t>
              </a:r>
              <a:endParaRPr lang="en-US" sz="1000" b="1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F1053A9-7C81-4D6E-881A-45ADD61E0C80}"/>
                </a:ext>
              </a:extLst>
            </p:cNvPr>
            <p:cNvSpPr txBox="1"/>
            <p:nvPr/>
          </p:nvSpPr>
          <p:spPr>
            <a:xfrm rot="18720000">
              <a:off x="3123602" y="1700165"/>
              <a:ext cx="1172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0F79200-2D2D-4069-863A-D6D006A0A555}"/>
                </a:ext>
              </a:extLst>
            </p:cNvPr>
            <p:cNvSpPr txBox="1"/>
            <p:nvPr/>
          </p:nvSpPr>
          <p:spPr>
            <a:xfrm rot="18720000">
              <a:off x="1885661" y="1931478"/>
              <a:ext cx="6163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3FD2151-D9A4-475E-AD7F-6025926AF15F}"/>
                </a:ext>
              </a:extLst>
            </p:cNvPr>
            <p:cNvSpPr txBox="1"/>
            <p:nvPr/>
          </p:nvSpPr>
          <p:spPr>
            <a:xfrm rot="18720000">
              <a:off x="2104947" y="1936316"/>
              <a:ext cx="6033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3126F8A-A150-49BF-998E-F17CD7E14B55}"/>
                </a:ext>
              </a:extLst>
            </p:cNvPr>
            <p:cNvSpPr txBox="1"/>
            <p:nvPr/>
          </p:nvSpPr>
          <p:spPr>
            <a:xfrm rot="18720000">
              <a:off x="2336312" y="1927622"/>
              <a:ext cx="5799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8C41AC49-3F57-4962-B195-0F7AF385C3FC}"/>
                </a:ext>
              </a:extLst>
            </p:cNvPr>
            <p:cNvSpPr txBox="1"/>
            <p:nvPr/>
          </p:nvSpPr>
          <p:spPr>
            <a:xfrm rot="18720000">
              <a:off x="2552053" y="1911244"/>
              <a:ext cx="603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1C65D738-EA57-46C4-ABAB-802D5AFE8328}"/>
                </a:ext>
              </a:extLst>
            </p:cNvPr>
            <p:cNvCxnSpPr/>
            <p:nvPr/>
          </p:nvCxnSpPr>
          <p:spPr>
            <a:xfrm>
              <a:off x="1178624" y="4080177"/>
              <a:ext cx="13936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B8576F94-2D6B-45FC-964F-11350FA0F9CB}"/>
                </a:ext>
              </a:extLst>
            </p:cNvPr>
            <p:cNvCxnSpPr/>
            <p:nvPr/>
          </p:nvCxnSpPr>
          <p:spPr>
            <a:xfrm>
              <a:off x="1178624" y="3855409"/>
              <a:ext cx="13936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C88CDFB-B9E1-48FE-9A91-E71F4A46EDE3}"/>
                </a:ext>
              </a:extLst>
            </p:cNvPr>
            <p:cNvSpPr/>
            <p:nvPr/>
          </p:nvSpPr>
          <p:spPr>
            <a:xfrm>
              <a:off x="838200" y="3951861"/>
              <a:ext cx="3707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50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4FF44C84-0AB9-4EB7-B955-FFBFFCCC7B22}"/>
                </a:ext>
              </a:extLst>
            </p:cNvPr>
            <p:cNvSpPr/>
            <p:nvPr/>
          </p:nvSpPr>
          <p:spPr>
            <a:xfrm>
              <a:off x="847496" y="3719232"/>
              <a:ext cx="361453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75</a:t>
              </a: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E0780119-7A34-4CCE-8DBB-B89DACFA646F}"/>
                </a:ext>
              </a:extLst>
            </p:cNvPr>
            <p:cNvCxnSpPr/>
            <p:nvPr/>
          </p:nvCxnSpPr>
          <p:spPr>
            <a:xfrm>
              <a:off x="1156603" y="4390645"/>
              <a:ext cx="139367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11924C80-56EB-4FE4-B0EC-9D3ABB1269A5}"/>
                </a:ext>
              </a:extLst>
            </p:cNvPr>
            <p:cNvSpPr/>
            <p:nvPr/>
          </p:nvSpPr>
          <p:spPr>
            <a:xfrm>
              <a:off x="841669" y="4254468"/>
              <a:ext cx="39901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25</a:t>
              </a:r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984B165-1C0E-40BD-BCC3-1AE04424A3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9633" y="2151516"/>
              <a:ext cx="2727065" cy="2932149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F12EDE7-9CB1-4ABB-BE4E-5F0196A04CEA}"/>
                </a:ext>
              </a:extLst>
            </p:cNvPr>
            <p:cNvSpPr txBox="1"/>
            <p:nvPr/>
          </p:nvSpPr>
          <p:spPr>
            <a:xfrm rot="18720000">
              <a:off x="6639805" y="1818404"/>
              <a:ext cx="7394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 5 ng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BB4EEB-12D1-4384-B94F-2A5EF9143ADA}"/>
                </a:ext>
              </a:extLst>
            </p:cNvPr>
            <p:cNvSpPr txBox="1"/>
            <p:nvPr/>
          </p:nvSpPr>
          <p:spPr>
            <a:xfrm rot="18720000">
              <a:off x="4827723" y="1607741"/>
              <a:ext cx="1238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974854B-97BA-4E3C-8B56-93C38DB976AD}"/>
                </a:ext>
              </a:extLst>
            </p:cNvPr>
            <p:cNvSpPr txBox="1"/>
            <p:nvPr/>
          </p:nvSpPr>
          <p:spPr>
            <a:xfrm rot="18720000">
              <a:off x="5348018" y="1684916"/>
              <a:ext cx="1031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62098FC-6D38-493B-9B1B-BA822EA8748D}"/>
                </a:ext>
              </a:extLst>
            </p:cNvPr>
            <p:cNvSpPr txBox="1"/>
            <p:nvPr/>
          </p:nvSpPr>
          <p:spPr>
            <a:xfrm rot="18720000">
              <a:off x="5255674" y="1892010"/>
              <a:ext cx="4696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5246805-1C3C-40E4-AE70-347FF5BBD7DF}"/>
                </a:ext>
              </a:extLst>
            </p:cNvPr>
            <p:cNvSpPr txBox="1"/>
            <p:nvPr/>
          </p:nvSpPr>
          <p:spPr>
            <a:xfrm rot="18720000">
              <a:off x="7062537" y="1584792"/>
              <a:ext cx="1238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46BEC42-4B2A-443A-9447-A4EF70DBF75E}"/>
                </a:ext>
              </a:extLst>
            </p:cNvPr>
            <p:cNvSpPr txBox="1"/>
            <p:nvPr/>
          </p:nvSpPr>
          <p:spPr>
            <a:xfrm rot="18720000">
              <a:off x="5682603" y="1849580"/>
              <a:ext cx="5962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43E74A5-F996-4993-A407-CB5BE45F6F93}"/>
                </a:ext>
              </a:extLst>
            </p:cNvPr>
            <p:cNvSpPr txBox="1"/>
            <p:nvPr/>
          </p:nvSpPr>
          <p:spPr>
            <a:xfrm rot="18720000">
              <a:off x="5934615" y="1822374"/>
              <a:ext cx="6378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18ECA61-756A-4A5D-B258-E23685390C66}"/>
                </a:ext>
              </a:extLst>
            </p:cNvPr>
            <p:cNvSpPr txBox="1"/>
            <p:nvPr/>
          </p:nvSpPr>
          <p:spPr>
            <a:xfrm rot="18720000">
              <a:off x="6162247" y="1832811"/>
              <a:ext cx="613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7E5C9B9-4C8C-4214-8A6A-51351CE977C6}"/>
                </a:ext>
              </a:extLst>
            </p:cNvPr>
            <p:cNvSpPr txBox="1"/>
            <p:nvPr/>
          </p:nvSpPr>
          <p:spPr>
            <a:xfrm rot="18720000">
              <a:off x="6398094" y="1849580"/>
              <a:ext cx="638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E6D4D06D-BDD7-49CC-AF3A-F43422A40992}"/>
                </a:ext>
              </a:extLst>
            </p:cNvPr>
            <p:cNvSpPr/>
            <p:nvPr/>
          </p:nvSpPr>
          <p:spPr>
            <a:xfrm>
              <a:off x="4525783" y="2182542"/>
              <a:ext cx="483607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 err="1"/>
                <a:t>kD</a:t>
              </a:r>
              <a:endParaRPr lang="en-US" sz="1000" b="1" dirty="0"/>
            </a:p>
          </p:txBody>
        </p:sp>
        <p:cxnSp>
          <p:nvCxnSpPr>
            <p:cNvPr id="35" name="Straight Arrow Connector 34">
              <a:extLst>
                <a:ext uri="{FF2B5EF4-FFF2-40B4-BE49-F238E27FC236}">
                  <a16:creationId xmlns:a16="http://schemas.microsoft.com/office/drawing/2014/main" id="{943FED0E-2E0A-4993-99B9-039B4705539D}"/>
                </a:ext>
              </a:extLst>
            </p:cNvPr>
            <p:cNvCxnSpPr/>
            <p:nvPr/>
          </p:nvCxnSpPr>
          <p:spPr>
            <a:xfrm>
              <a:off x="4773533" y="4222656"/>
              <a:ext cx="15436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22CA7670-DF02-403D-B19A-C034957764D9}"/>
                </a:ext>
              </a:extLst>
            </p:cNvPr>
            <p:cNvCxnSpPr/>
            <p:nvPr/>
          </p:nvCxnSpPr>
          <p:spPr>
            <a:xfrm>
              <a:off x="4773533" y="3933398"/>
              <a:ext cx="15436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570853AA-C985-4477-9745-1D98AA6F48C7}"/>
                </a:ext>
              </a:extLst>
            </p:cNvPr>
            <p:cNvSpPr/>
            <p:nvPr/>
          </p:nvSpPr>
          <p:spPr>
            <a:xfrm>
              <a:off x="4492334" y="4087011"/>
              <a:ext cx="48706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50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41BAABD6-58CE-4C98-8855-0FE9E76B42E2}"/>
                </a:ext>
              </a:extLst>
            </p:cNvPr>
            <p:cNvSpPr/>
            <p:nvPr/>
          </p:nvSpPr>
          <p:spPr>
            <a:xfrm>
              <a:off x="4508666" y="3789444"/>
              <a:ext cx="36471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75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0EAA1F66-0F14-433C-A1D9-32D59BF5B343}"/>
                </a:ext>
              </a:extLst>
            </p:cNvPr>
            <p:cNvCxnSpPr/>
            <p:nvPr/>
          </p:nvCxnSpPr>
          <p:spPr>
            <a:xfrm>
              <a:off x="4749143" y="4571516"/>
              <a:ext cx="154362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4C440166-34F4-4BDA-91DE-9619BC81E82C}"/>
                </a:ext>
              </a:extLst>
            </p:cNvPr>
            <p:cNvSpPr/>
            <p:nvPr/>
          </p:nvSpPr>
          <p:spPr>
            <a:xfrm>
              <a:off x="4486027" y="4427562"/>
              <a:ext cx="32688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25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3F8A96D-50A8-4AED-92D7-4E1653101CF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74680" y="2069624"/>
              <a:ext cx="2730872" cy="3014042"/>
            </a:xfrm>
            <a:prstGeom prst="rect">
              <a:avLst/>
            </a:prstGeom>
          </p:spPr>
        </p:pic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7D09DA34-C5F9-4592-BD49-B44609E41C82}"/>
                </a:ext>
              </a:extLst>
            </p:cNvPr>
            <p:cNvCxnSpPr/>
            <p:nvPr/>
          </p:nvCxnSpPr>
          <p:spPr>
            <a:xfrm>
              <a:off x="8579915" y="4161710"/>
              <a:ext cx="17865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A8BCCDC2-9026-4FB5-9706-7FC2CD94D7A9}"/>
                </a:ext>
              </a:extLst>
            </p:cNvPr>
            <p:cNvCxnSpPr/>
            <p:nvPr/>
          </p:nvCxnSpPr>
          <p:spPr>
            <a:xfrm>
              <a:off x="8579915" y="3907585"/>
              <a:ext cx="17865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157C415-B40D-4426-920E-42626169D37B}"/>
                </a:ext>
              </a:extLst>
            </p:cNvPr>
            <p:cNvSpPr/>
            <p:nvPr/>
          </p:nvSpPr>
          <p:spPr>
            <a:xfrm>
              <a:off x="8306522" y="4041493"/>
              <a:ext cx="44478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50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DDE08C6-DFF6-49FA-820D-7D222F543F38}"/>
                </a:ext>
              </a:extLst>
            </p:cNvPr>
            <p:cNvSpPr/>
            <p:nvPr/>
          </p:nvSpPr>
          <p:spPr>
            <a:xfrm>
              <a:off x="8306521" y="3779191"/>
              <a:ext cx="444788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75</a:t>
              </a: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561FC159-C1E6-4C8C-82FF-761C9D04A5B0}"/>
                </a:ext>
              </a:extLst>
            </p:cNvPr>
            <p:cNvCxnSpPr/>
            <p:nvPr/>
          </p:nvCxnSpPr>
          <p:spPr>
            <a:xfrm>
              <a:off x="8551686" y="4464318"/>
              <a:ext cx="17865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32CF726-B8B7-4639-AEC6-67D6772C536A}"/>
                </a:ext>
              </a:extLst>
            </p:cNvPr>
            <p:cNvSpPr/>
            <p:nvPr/>
          </p:nvSpPr>
          <p:spPr>
            <a:xfrm>
              <a:off x="8306520" y="4335925"/>
              <a:ext cx="45149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/>
                <a:t>25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6054C4F-46B5-4777-BDCD-05864A593945}"/>
                </a:ext>
              </a:extLst>
            </p:cNvPr>
            <p:cNvSpPr txBox="1"/>
            <p:nvPr/>
          </p:nvSpPr>
          <p:spPr>
            <a:xfrm rot="18720000">
              <a:off x="10468524" y="1749115"/>
              <a:ext cx="8130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5 ng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CDDE8F8-1628-4678-B580-EA9AC9DEE458}"/>
                </a:ext>
              </a:extLst>
            </p:cNvPr>
            <p:cNvSpPr txBox="1"/>
            <p:nvPr/>
          </p:nvSpPr>
          <p:spPr>
            <a:xfrm rot="18720000">
              <a:off x="8651209" y="1669718"/>
              <a:ext cx="1219077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34F133C-EF6C-426C-B1F9-559CD77E35F0}"/>
                </a:ext>
              </a:extLst>
            </p:cNvPr>
            <p:cNvSpPr txBox="1"/>
            <p:nvPr/>
          </p:nvSpPr>
          <p:spPr>
            <a:xfrm rot="18720000">
              <a:off x="9285097" y="1860892"/>
              <a:ext cx="577484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3B63CFC-BE5E-417F-92E7-8AC7F3A1CEC5}"/>
                </a:ext>
              </a:extLst>
            </p:cNvPr>
            <p:cNvSpPr txBox="1"/>
            <p:nvPr/>
          </p:nvSpPr>
          <p:spPr>
            <a:xfrm rot="18720000">
              <a:off x="9089039" y="1943677"/>
              <a:ext cx="462162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5A061E6-DA85-45DF-A55F-FD749355071B}"/>
                </a:ext>
              </a:extLst>
            </p:cNvPr>
            <p:cNvSpPr txBox="1"/>
            <p:nvPr/>
          </p:nvSpPr>
          <p:spPr>
            <a:xfrm rot="18720000">
              <a:off x="9535095" y="1877439"/>
              <a:ext cx="586688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91B4293-9706-4F40-AD2E-877726392215}"/>
                </a:ext>
              </a:extLst>
            </p:cNvPr>
            <p:cNvSpPr txBox="1"/>
            <p:nvPr/>
          </p:nvSpPr>
          <p:spPr>
            <a:xfrm rot="18720000">
              <a:off x="9779112" y="1865231"/>
              <a:ext cx="627585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7E06195-E30E-4297-BE47-58D3F942A292}"/>
                </a:ext>
              </a:extLst>
            </p:cNvPr>
            <p:cNvSpPr txBox="1"/>
            <p:nvPr/>
          </p:nvSpPr>
          <p:spPr>
            <a:xfrm rot="18720000">
              <a:off x="10024589" y="1866207"/>
              <a:ext cx="603250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85EE968-6C35-4D6D-9ED7-22AC483115B0}"/>
                </a:ext>
              </a:extLst>
            </p:cNvPr>
            <p:cNvSpPr txBox="1"/>
            <p:nvPr/>
          </p:nvSpPr>
          <p:spPr>
            <a:xfrm rot="18720000">
              <a:off x="10268488" y="1837644"/>
              <a:ext cx="628194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6E0395B3-1321-4A33-8C0D-22A972F2ABB4}"/>
                </a:ext>
              </a:extLst>
            </p:cNvPr>
            <p:cNvSpPr/>
            <p:nvPr/>
          </p:nvSpPr>
          <p:spPr>
            <a:xfrm>
              <a:off x="8344308" y="2168797"/>
              <a:ext cx="333301" cy="18886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 err="1"/>
                <a:t>kD</a:t>
              </a:r>
              <a:endParaRPr lang="en-US" sz="1000" b="1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93530B48-4BF9-485F-A067-1E222FE90AA5}"/>
                </a:ext>
              </a:extLst>
            </p:cNvPr>
            <p:cNvSpPr txBox="1"/>
            <p:nvPr/>
          </p:nvSpPr>
          <p:spPr>
            <a:xfrm rot="18720000">
              <a:off x="6890009" y="1787791"/>
              <a:ext cx="8266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 10 ng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E1A810F-0D8E-4BAD-9A4C-69207D513D2B}"/>
                </a:ext>
              </a:extLst>
            </p:cNvPr>
            <p:cNvSpPr txBox="1"/>
            <p:nvPr/>
          </p:nvSpPr>
          <p:spPr>
            <a:xfrm rot="18720000">
              <a:off x="2968211" y="1815469"/>
              <a:ext cx="8524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 10 ng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6097A1B-749D-4EF1-BA24-B5D9B6F5E7FD}"/>
                </a:ext>
              </a:extLst>
            </p:cNvPr>
            <p:cNvSpPr txBox="1"/>
            <p:nvPr/>
          </p:nvSpPr>
          <p:spPr>
            <a:xfrm rot="18720000">
              <a:off x="10703870" y="1713157"/>
              <a:ext cx="811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 10 ng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EBB34B2-D16C-48D7-BC12-A546EE945C66}"/>
                </a:ext>
              </a:extLst>
            </p:cNvPr>
            <p:cNvSpPr txBox="1"/>
            <p:nvPr/>
          </p:nvSpPr>
          <p:spPr>
            <a:xfrm>
              <a:off x="1297270" y="5144326"/>
              <a:ext cx="982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                7 days                                                     14 days                                                                21 day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595051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10D0EA79-AF22-4602-A1E8-5D0978CA1AC5}"/>
              </a:ext>
            </a:extLst>
          </p:cNvPr>
          <p:cNvSpPr txBox="1"/>
          <p:nvPr/>
        </p:nvSpPr>
        <p:spPr>
          <a:xfrm>
            <a:off x="1347755" y="6114723"/>
            <a:ext cx="62310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w Western blot images for Fig. 3.  </a:t>
            </a:r>
          </a:p>
          <a:p>
            <a:endParaRPr lang="en-US" dirty="0"/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AABAF1BB-E099-4971-AAD9-319042D8820F}"/>
              </a:ext>
            </a:extLst>
          </p:cNvPr>
          <p:cNvGrpSpPr/>
          <p:nvPr/>
        </p:nvGrpSpPr>
        <p:grpSpPr>
          <a:xfrm>
            <a:off x="1049344" y="1805489"/>
            <a:ext cx="10414454" cy="3930419"/>
            <a:chOff x="1049344" y="1805489"/>
            <a:chExt cx="10414454" cy="3930419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71B45AC-AAA7-4830-9F7D-756B20262FE3}"/>
                </a:ext>
              </a:extLst>
            </p:cNvPr>
            <p:cNvSpPr txBox="1"/>
            <p:nvPr/>
          </p:nvSpPr>
          <p:spPr>
            <a:xfrm>
              <a:off x="1270392" y="5366576"/>
              <a:ext cx="9829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                   7 days                                                     14 days                                                          21 days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C26531E-5612-4E50-89B4-3621BC23C94C}"/>
                </a:ext>
              </a:extLst>
            </p:cNvPr>
            <p:cNvSpPr txBox="1"/>
            <p:nvPr/>
          </p:nvSpPr>
          <p:spPr>
            <a:xfrm rot="18720000">
              <a:off x="2706862" y="2557076"/>
              <a:ext cx="920245" cy="2491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5 ng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391537B-25C7-4B83-AB66-8045FE5CF442}"/>
                </a:ext>
              </a:extLst>
            </p:cNvPr>
            <p:cNvSpPr txBox="1"/>
            <p:nvPr/>
          </p:nvSpPr>
          <p:spPr>
            <a:xfrm rot="18720000">
              <a:off x="989407" y="2505099"/>
              <a:ext cx="1172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375AFAE-75E9-4A1D-8EC8-B836E360552F}"/>
                </a:ext>
              </a:extLst>
            </p:cNvPr>
            <p:cNvSpPr txBox="1"/>
            <p:nvPr/>
          </p:nvSpPr>
          <p:spPr>
            <a:xfrm rot="18720000">
              <a:off x="1503582" y="2526126"/>
              <a:ext cx="975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3D2A363-7265-4EDF-827F-23D81AFD4050}"/>
                </a:ext>
              </a:extLst>
            </p:cNvPr>
            <p:cNvSpPr txBox="1"/>
            <p:nvPr/>
          </p:nvSpPr>
          <p:spPr>
            <a:xfrm rot="18720000">
              <a:off x="1275524" y="2509526"/>
              <a:ext cx="9755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8E39978-E49F-4715-823D-F7E378B68FD6}"/>
                </a:ext>
              </a:extLst>
            </p:cNvPr>
            <p:cNvSpPr txBox="1"/>
            <p:nvPr/>
          </p:nvSpPr>
          <p:spPr>
            <a:xfrm rot="18720000">
              <a:off x="3096558" y="2457273"/>
              <a:ext cx="1172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35CFD89-E7CA-4463-BC02-DA4B9152BBFD}"/>
                </a:ext>
              </a:extLst>
            </p:cNvPr>
            <p:cNvSpPr txBox="1"/>
            <p:nvPr/>
          </p:nvSpPr>
          <p:spPr>
            <a:xfrm rot="18720000">
              <a:off x="1796602" y="2661513"/>
              <a:ext cx="6163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791E417-3B82-4BA8-B2DE-7C48C86DFC8D}"/>
                </a:ext>
              </a:extLst>
            </p:cNvPr>
            <p:cNvSpPr txBox="1"/>
            <p:nvPr/>
          </p:nvSpPr>
          <p:spPr>
            <a:xfrm rot="18720000">
              <a:off x="2028647" y="2654493"/>
              <a:ext cx="6033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A90D19C-93B6-4B2A-8F54-C2B8CD17D86C}"/>
                </a:ext>
              </a:extLst>
            </p:cNvPr>
            <p:cNvSpPr txBox="1"/>
            <p:nvPr/>
          </p:nvSpPr>
          <p:spPr>
            <a:xfrm rot="18720000">
              <a:off x="2311297" y="2671418"/>
              <a:ext cx="5799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2A455E9-F62D-4915-9964-B2876A37B6F6}"/>
                </a:ext>
              </a:extLst>
            </p:cNvPr>
            <p:cNvSpPr txBox="1"/>
            <p:nvPr/>
          </p:nvSpPr>
          <p:spPr>
            <a:xfrm rot="18720000">
              <a:off x="2542104" y="2683838"/>
              <a:ext cx="603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292C007-2BC2-4341-8B77-CC515586AA79}"/>
                </a:ext>
              </a:extLst>
            </p:cNvPr>
            <p:cNvSpPr txBox="1"/>
            <p:nvPr/>
          </p:nvSpPr>
          <p:spPr>
            <a:xfrm rot="18720000">
              <a:off x="6562000" y="2460862"/>
              <a:ext cx="11121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 5 ng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830CF92-A5E1-4B20-B983-C4354EA0B2A4}"/>
                </a:ext>
              </a:extLst>
            </p:cNvPr>
            <p:cNvSpPr txBox="1"/>
            <p:nvPr/>
          </p:nvSpPr>
          <p:spPr>
            <a:xfrm rot="18720000">
              <a:off x="4565459" y="2432379"/>
              <a:ext cx="1238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3B5383C-EA3D-446A-8FFC-1D1980E12BA6}"/>
                </a:ext>
              </a:extLst>
            </p:cNvPr>
            <p:cNvSpPr txBox="1"/>
            <p:nvPr/>
          </p:nvSpPr>
          <p:spPr>
            <a:xfrm rot="18720000">
              <a:off x="5230347" y="2488826"/>
              <a:ext cx="1031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9B6D61F-6EEA-4F1B-802A-EE2AB5E54F8E}"/>
                </a:ext>
              </a:extLst>
            </p:cNvPr>
            <p:cNvSpPr txBox="1"/>
            <p:nvPr/>
          </p:nvSpPr>
          <p:spPr>
            <a:xfrm rot="18720000">
              <a:off x="5086751" y="2654028"/>
              <a:ext cx="4696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BB4735D-EB86-4920-8A6B-DD8D57306305}"/>
                </a:ext>
              </a:extLst>
            </p:cNvPr>
            <p:cNvSpPr txBox="1"/>
            <p:nvPr/>
          </p:nvSpPr>
          <p:spPr>
            <a:xfrm rot="18720000">
              <a:off x="7021739" y="2353295"/>
              <a:ext cx="12389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760A8B7-0AD4-44AA-B62B-EE571454603E}"/>
                </a:ext>
              </a:extLst>
            </p:cNvPr>
            <p:cNvSpPr txBox="1"/>
            <p:nvPr/>
          </p:nvSpPr>
          <p:spPr>
            <a:xfrm rot="18720000">
              <a:off x="5578893" y="2636044"/>
              <a:ext cx="5962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2A6D327-3851-43E1-B1FD-429B0D891FAD}"/>
                </a:ext>
              </a:extLst>
            </p:cNvPr>
            <p:cNvSpPr txBox="1"/>
            <p:nvPr/>
          </p:nvSpPr>
          <p:spPr>
            <a:xfrm rot="18720000">
              <a:off x="5845074" y="2606796"/>
              <a:ext cx="6378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AD54850-E6C1-46E8-BE31-4C289239DB60}"/>
                </a:ext>
              </a:extLst>
            </p:cNvPr>
            <p:cNvSpPr txBox="1"/>
            <p:nvPr/>
          </p:nvSpPr>
          <p:spPr>
            <a:xfrm rot="18720000">
              <a:off x="6151639" y="2604631"/>
              <a:ext cx="613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4D58215-8F69-4041-8747-129FD0B5A4D7}"/>
                </a:ext>
              </a:extLst>
            </p:cNvPr>
            <p:cNvSpPr txBox="1"/>
            <p:nvPr/>
          </p:nvSpPr>
          <p:spPr>
            <a:xfrm rot="18720000">
              <a:off x="6401418" y="2611518"/>
              <a:ext cx="6384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66EFC954-4E93-4622-9041-5AA47AEA9220}"/>
                </a:ext>
              </a:extLst>
            </p:cNvPr>
            <p:cNvSpPr txBox="1"/>
            <p:nvPr/>
          </p:nvSpPr>
          <p:spPr>
            <a:xfrm rot="18720000">
              <a:off x="10372018" y="2470204"/>
              <a:ext cx="9715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5 ng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5620E32-EF64-43F0-A885-8B4AA780D85E}"/>
                </a:ext>
              </a:extLst>
            </p:cNvPr>
            <p:cNvSpPr txBox="1"/>
            <p:nvPr/>
          </p:nvSpPr>
          <p:spPr>
            <a:xfrm rot="18720000">
              <a:off x="8547992" y="2441538"/>
              <a:ext cx="1219077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7E06ACD-0F41-4625-8BDF-7E7A64101856}"/>
                </a:ext>
              </a:extLst>
            </p:cNvPr>
            <p:cNvSpPr txBox="1"/>
            <p:nvPr/>
          </p:nvSpPr>
          <p:spPr>
            <a:xfrm rot="18720000">
              <a:off x="9181880" y="2632712"/>
              <a:ext cx="577484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74D8BD5-9269-4085-9BD7-99861BD2C55E}"/>
                </a:ext>
              </a:extLst>
            </p:cNvPr>
            <p:cNvSpPr txBox="1"/>
            <p:nvPr/>
          </p:nvSpPr>
          <p:spPr>
            <a:xfrm rot="18720000">
              <a:off x="8985822" y="2715497"/>
              <a:ext cx="462162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HC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662C429-8485-4044-9004-C67383100645}"/>
                </a:ext>
              </a:extLst>
            </p:cNvPr>
            <p:cNvSpPr txBox="1"/>
            <p:nvPr/>
          </p:nvSpPr>
          <p:spPr>
            <a:xfrm rot="18720000">
              <a:off x="10775227" y="2335996"/>
              <a:ext cx="1219077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rotein standard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7429D7A-93FE-4079-AC76-42329759E8CD}"/>
                </a:ext>
              </a:extLst>
            </p:cNvPr>
            <p:cNvSpPr txBox="1"/>
            <p:nvPr/>
          </p:nvSpPr>
          <p:spPr>
            <a:xfrm rot="18720000">
              <a:off x="9431878" y="2649259"/>
              <a:ext cx="586688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27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37F9F62-554C-4BB3-9444-1E040B12D58F}"/>
                </a:ext>
              </a:extLst>
            </p:cNvPr>
            <p:cNvSpPr txBox="1"/>
            <p:nvPr/>
          </p:nvSpPr>
          <p:spPr>
            <a:xfrm rot="18720000">
              <a:off x="9675895" y="2637051"/>
              <a:ext cx="627585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56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2087751-0636-43C9-BD45-5764929BC92E}"/>
                </a:ext>
              </a:extLst>
            </p:cNvPr>
            <p:cNvSpPr txBox="1"/>
            <p:nvPr/>
          </p:nvSpPr>
          <p:spPr>
            <a:xfrm rot="18720000">
              <a:off x="9921372" y="2638027"/>
              <a:ext cx="603250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68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50E18B7-40A3-4297-8DDC-947DFEC6CAB0}"/>
                </a:ext>
              </a:extLst>
            </p:cNvPr>
            <p:cNvSpPr txBox="1"/>
            <p:nvPr/>
          </p:nvSpPr>
          <p:spPr>
            <a:xfrm rot="18720000">
              <a:off x="10165271" y="2609464"/>
              <a:ext cx="628194" cy="1580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WX70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9FE54B36-2BAC-40CF-A645-CA00E430A50B}"/>
                </a:ext>
              </a:extLst>
            </p:cNvPr>
            <p:cNvSpPr txBox="1"/>
            <p:nvPr/>
          </p:nvSpPr>
          <p:spPr>
            <a:xfrm rot="18720000">
              <a:off x="6842930" y="2472615"/>
              <a:ext cx="9650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10 ng 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76A4D93-210B-4F3A-8459-E2FEE85B4EB9}"/>
                </a:ext>
              </a:extLst>
            </p:cNvPr>
            <p:cNvSpPr txBox="1"/>
            <p:nvPr/>
          </p:nvSpPr>
          <p:spPr>
            <a:xfrm rot="18720000">
              <a:off x="2921068" y="2545281"/>
              <a:ext cx="9768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10 ng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4E9D768-E36D-4E8A-ABB2-4D4C09A27D7C}"/>
                </a:ext>
              </a:extLst>
            </p:cNvPr>
            <p:cNvSpPr txBox="1"/>
            <p:nvPr/>
          </p:nvSpPr>
          <p:spPr>
            <a:xfrm rot="18720000">
              <a:off x="10580228" y="2422633"/>
              <a:ext cx="10092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+GFP 10 ng </a:t>
              </a:r>
            </a:p>
          </p:txBody>
        </p:sp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E1FECB22-429E-4699-B27C-F57B881C81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8817" y="3127422"/>
              <a:ext cx="2889993" cy="2204958"/>
            </a:xfrm>
            <a:prstGeom prst="rect">
              <a:avLst/>
            </a:prstGeom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4477B608-7BB5-4FFD-8BB4-ADE7B9622D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73359" y="3222736"/>
              <a:ext cx="2755433" cy="2180492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285B5B90-2C15-4D0B-899C-13A898DC600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49344" y="3179383"/>
              <a:ext cx="2725877" cy="20092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302831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C988C-72B6-4A53-B1DF-A57FB88F4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0961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27- Rep 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1A9061-A938-435C-878D-A1556447B3F7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2102308"/>
            <a:ext cx="3566160" cy="16459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2A9AFB9-080C-4969-9C28-B3203ECF5856}"/>
              </a:ext>
            </a:extLst>
          </p:cNvPr>
          <p:cNvSpPr txBox="1"/>
          <p:nvPr/>
        </p:nvSpPr>
        <p:spPr>
          <a:xfrm>
            <a:off x="1020417" y="1240517"/>
            <a:ext cx="9639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 Day 7                                                              Day 14                                                             Day 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514C17-4512-4EB3-BC69-E07F3897E13A}"/>
              </a:ext>
            </a:extLst>
          </p:cNvPr>
          <p:cNvSpPr txBox="1"/>
          <p:nvPr/>
        </p:nvSpPr>
        <p:spPr>
          <a:xfrm>
            <a:off x="107122" y="1731832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112 (1286bp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CC4165-DA57-4372-A9E8-FF67944E4E9F}"/>
              </a:ext>
            </a:extLst>
          </p:cNvPr>
          <p:cNvSpPr txBox="1"/>
          <p:nvPr/>
        </p:nvSpPr>
        <p:spPr>
          <a:xfrm>
            <a:off x="107122" y="3800399"/>
            <a:ext cx="2668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35 (765bp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FE1A0E2-351D-4F51-AF2E-7E4EFFC3C0F6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4108176"/>
            <a:ext cx="3566160" cy="16459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285A589-5B04-45D8-9E2F-C46F6080BA8A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2102308"/>
            <a:ext cx="3566160" cy="164592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F1A23B9-94E2-4CE1-A482-9979DF50FCE5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4108176"/>
            <a:ext cx="3566160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DB9A5F1-3C86-4AFB-894E-9D71F301064D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4108176"/>
            <a:ext cx="3566160" cy="16459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88D9E6E-6243-4358-88DE-240B8FE3D828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2102308"/>
            <a:ext cx="3566160" cy="16459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45F3A58-6EF2-4993-A3FA-F777E18B649F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4543455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24133-AECE-457C-A9EF-AEAA9F010C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6804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27- Rep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4713A1-9AA7-44DF-9E94-75F8987D11BB}"/>
              </a:ext>
            </a:extLst>
          </p:cNvPr>
          <p:cNvSpPr txBox="1"/>
          <p:nvPr/>
        </p:nvSpPr>
        <p:spPr>
          <a:xfrm>
            <a:off x="1020417" y="1057640"/>
            <a:ext cx="953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  Day 7                                                            Day 14                                                              Day 2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054A121-8FEF-409D-89C2-1964BFBF4E68}"/>
              </a:ext>
            </a:extLst>
          </p:cNvPr>
          <p:cNvSpPr txBox="1"/>
          <p:nvPr/>
        </p:nvSpPr>
        <p:spPr>
          <a:xfrm>
            <a:off x="107122" y="1548961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112 (1286bp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63876ED-BD3E-4212-A4D9-F737C136C23B}"/>
              </a:ext>
            </a:extLst>
          </p:cNvPr>
          <p:cNvSpPr txBox="1"/>
          <p:nvPr/>
        </p:nvSpPr>
        <p:spPr>
          <a:xfrm>
            <a:off x="107122" y="3718734"/>
            <a:ext cx="2668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35 (765bp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A0B9EA8-2B86-4F05-BF0F-1B9A0EC28CD6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4139200"/>
            <a:ext cx="3566160" cy="16459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349EA63-254D-46C8-9639-8AE744C147D3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1960126"/>
            <a:ext cx="3566160" cy="16459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D986DF8-F4E3-4B4F-AF6D-86A9F571F036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1960126"/>
            <a:ext cx="3566160" cy="164592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DF1AC02-1494-4FBE-9D8F-A77B99AF4FD1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4139200"/>
            <a:ext cx="3566160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0E7D687-3549-457D-BC1D-309A89264022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1960126"/>
            <a:ext cx="3566160" cy="16459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26F0F9E-F0F1-4AE5-89C2-C1CDD498131E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4139200"/>
            <a:ext cx="3566160" cy="16459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4EDF687-6D73-46C3-B4BC-1E8301D276A1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33086813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7EA9A-0B0C-4EC1-986E-75C5847278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10065" y="13994"/>
            <a:ext cx="3607191" cy="1256029"/>
          </a:xfrm>
        </p:spPr>
        <p:txBody>
          <a:bodyPr>
            <a:normAutofit/>
          </a:bodyPr>
          <a:lstStyle/>
          <a:p>
            <a:r>
              <a:rPr lang="en-US" sz="4000" dirty="0"/>
              <a:t>pWX27- Rep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8509B2E-EF7B-47B1-83E9-B3BD9723D4B8}"/>
              </a:ext>
            </a:extLst>
          </p:cNvPr>
          <p:cNvSpPr txBox="1"/>
          <p:nvPr/>
        </p:nvSpPr>
        <p:spPr>
          <a:xfrm>
            <a:off x="981143" y="1270023"/>
            <a:ext cx="9533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   Day 7                                                               Day 14                                                            Day 2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715AFC-39FF-43BD-84DA-E90266BF8029}"/>
              </a:ext>
            </a:extLst>
          </p:cNvPr>
          <p:cNvSpPr txBox="1"/>
          <p:nvPr/>
        </p:nvSpPr>
        <p:spPr>
          <a:xfrm>
            <a:off x="107122" y="1684255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112 (1286bp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A2E6474-38CD-4402-A9DF-984ED80B1418}"/>
              </a:ext>
            </a:extLst>
          </p:cNvPr>
          <p:cNvSpPr txBox="1"/>
          <p:nvPr/>
        </p:nvSpPr>
        <p:spPr>
          <a:xfrm>
            <a:off x="107122" y="3814468"/>
            <a:ext cx="26686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111/WX35 (765bp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E097B6-0A50-47A3-B85F-68053E676133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4133671"/>
            <a:ext cx="3566160" cy="164592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3528D9A-9AFE-469A-8B3C-BB8DCF103BC0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2100279"/>
            <a:ext cx="3566160" cy="16459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F96FE75-2CD5-4766-A6B7-316BB6AFA463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4133671"/>
            <a:ext cx="3566160" cy="16459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1677B0A-11E6-472A-86AB-26E4116355A1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4119603"/>
            <a:ext cx="3566160" cy="164592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C49EEA4-AD73-4309-8AFE-BDF9E86FBA94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2086211"/>
            <a:ext cx="3566160" cy="164592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97D7B57-269E-4F6E-9FDB-398FCB11BA79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9CB18B8-1983-4461-8F1F-80DD018DA276}"/>
              </a:ext>
            </a:extLst>
          </p:cNvPr>
          <p:cNvPicPr>
            <a:picLocks/>
          </p:cNvPicPr>
          <p:nvPr/>
        </p:nvPicPr>
        <p:blipFill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3381" y="2100279"/>
            <a:ext cx="3566159" cy="163185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947277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0C988C-72B6-4A53-B1DF-A57FB88F4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0961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68- Rep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A9AFB9-080C-4969-9C28-B3203ECF5856}"/>
              </a:ext>
            </a:extLst>
          </p:cNvPr>
          <p:cNvSpPr txBox="1"/>
          <p:nvPr/>
        </p:nvSpPr>
        <p:spPr>
          <a:xfrm>
            <a:off x="1020417" y="1240517"/>
            <a:ext cx="9427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Day 7                                                                 Day 14                                                           Day 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F514C17-4512-4EB3-BC69-E07F3897E13A}"/>
              </a:ext>
            </a:extLst>
          </p:cNvPr>
          <p:cNvSpPr txBox="1"/>
          <p:nvPr/>
        </p:nvSpPr>
        <p:spPr>
          <a:xfrm>
            <a:off x="107122" y="1731832"/>
            <a:ext cx="27599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CC4165-DA57-4372-A9E8-FF67944E4E9F}"/>
              </a:ext>
            </a:extLst>
          </p:cNvPr>
          <p:cNvSpPr txBox="1"/>
          <p:nvPr/>
        </p:nvSpPr>
        <p:spPr>
          <a:xfrm>
            <a:off x="107122" y="3800399"/>
            <a:ext cx="2708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4 (505bp)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A850A65-E296-4969-B654-646B3314A7B8}"/>
              </a:ext>
            </a:extLst>
          </p:cNvPr>
          <p:cNvPicPr>
            <a:picLocks/>
          </p:cNvPicPr>
          <p:nvPr/>
        </p:nvPicPr>
        <p:blipFill rotWithShape="1">
          <a:blip r:embed="rId2" cstate="screen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2046603"/>
            <a:ext cx="3566160" cy="164592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D274E35-54D7-4265-BD3F-CC680EA5C42C}"/>
              </a:ext>
            </a:extLst>
          </p:cNvPr>
          <p:cNvPicPr>
            <a:picLocks/>
          </p:cNvPicPr>
          <p:nvPr/>
        </p:nvPicPr>
        <p:blipFill rotWithShape="1"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4131644"/>
            <a:ext cx="3566160" cy="16459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C40DB15-F373-4E30-A771-236D06A12D5D}"/>
              </a:ext>
            </a:extLst>
          </p:cNvPr>
          <p:cNvPicPr>
            <a:picLocks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2036052"/>
            <a:ext cx="3566160" cy="16459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9114C6D-639C-40C7-B80E-9D17826CA7AD}"/>
              </a:ext>
            </a:extLst>
          </p:cNvPr>
          <p:cNvPicPr>
            <a:picLocks/>
          </p:cNvPicPr>
          <p:nvPr/>
        </p:nvPicPr>
        <p:blipFill rotWithShape="1"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4131644"/>
            <a:ext cx="3566160" cy="164592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78AE4B4-97B6-4A99-B5E6-92DE8D9AA518}"/>
              </a:ext>
            </a:extLst>
          </p:cNvPr>
          <p:cNvPicPr>
            <a:picLocks/>
          </p:cNvPicPr>
          <p:nvPr/>
        </p:nvPicPr>
        <p:blipFill rotWithShape="1"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2046603"/>
            <a:ext cx="3566160" cy="164592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05B9FB4-1F4B-4A5A-BDDA-4B2ADF89F631}"/>
              </a:ext>
            </a:extLst>
          </p:cNvPr>
          <p:cNvPicPr>
            <a:picLocks/>
          </p:cNvPicPr>
          <p:nvPr/>
        </p:nvPicPr>
        <p:blipFill rotWithShape="1"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4131644"/>
            <a:ext cx="3566160" cy="164592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D3B7544-1CDA-4DEA-8E99-84D76957F7A8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34933114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24133-AECE-457C-A9EF-AEAA9F010C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3425"/>
            <a:ext cx="3368040" cy="1325563"/>
          </a:xfrm>
        </p:spPr>
        <p:txBody>
          <a:bodyPr>
            <a:normAutofit/>
          </a:bodyPr>
          <a:lstStyle/>
          <a:p>
            <a:r>
              <a:rPr lang="en-US" sz="4000" dirty="0"/>
              <a:t>pWX68- Rep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4713A1-9AA7-44DF-9E94-75F8987D11BB}"/>
              </a:ext>
            </a:extLst>
          </p:cNvPr>
          <p:cNvSpPr txBox="1"/>
          <p:nvPr/>
        </p:nvSpPr>
        <p:spPr>
          <a:xfrm>
            <a:off x="1020417" y="1057640"/>
            <a:ext cx="9851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                Day 7                                                                 Day 14                                                             Day 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63876ED-BD3E-4212-A4D9-F737C136C23B}"/>
              </a:ext>
            </a:extLst>
          </p:cNvPr>
          <p:cNvSpPr txBox="1"/>
          <p:nvPr/>
        </p:nvSpPr>
        <p:spPr>
          <a:xfrm>
            <a:off x="107122" y="3631600"/>
            <a:ext cx="27086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4 (505bp)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5F953AEF-D665-4665-B28B-09BD15014D96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1879005"/>
            <a:ext cx="3566160" cy="164592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E690F9F-F641-4D4C-8240-54E09B128FFA}"/>
              </a:ext>
            </a:extLst>
          </p:cNvPr>
          <p:cNvPicPr>
            <a:picLocks/>
          </p:cNvPicPr>
          <p:nvPr/>
        </p:nvPicPr>
        <p:blipFill rotWithShape="1"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3380" y="3962890"/>
            <a:ext cx="3566160" cy="164592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5216C47-C3B9-454D-8E9E-6D3AA5E7D5E9}"/>
              </a:ext>
            </a:extLst>
          </p:cNvPr>
          <p:cNvPicPr>
            <a:picLocks/>
          </p:cNvPicPr>
          <p:nvPr/>
        </p:nvPicPr>
        <p:blipFill rotWithShape="1">
          <a:blip r:embed="rId6" cstate="email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1879005"/>
            <a:ext cx="3566160" cy="164592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6A269F7-8779-44AD-80F8-23620E977BB1}"/>
              </a:ext>
            </a:extLst>
          </p:cNvPr>
          <p:cNvPicPr>
            <a:picLocks/>
          </p:cNvPicPr>
          <p:nvPr/>
        </p:nvPicPr>
        <p:blipFill rotWithShape="1">
          <a:blip r:embed="rId8" cstate="email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312920" y="3962890"/>
            <a:ext cx="3566160" cy="164592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B3EDFBF-4616-4ABF-9384-B5790DDEA14E}"/>
              </a:ext>
            </a:extLst>
          </p:cNvPr>
          <p:cNvPicPr>
            <a:picLocks/>
          </p:cNvPicPr>
          <p:nvPr/>
        </p:nvPicPr>
        <p:blipFill rotWithShape="1">
          <a:blip r:embed="rId10" cstate="email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1879005"/>
            <a:ext cx="3566160" cy="164592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E388B4F-DAC6-4766-A54C-B4CB5119DE67}"/>
              </a:ext>
            </a:extLst>
          </p:cNvPr>
          <p:cNvPicPr>
            <a:picLocks/>
          </p:cNvPicPr>
          <p:nvPr/>
        </p:nvPicPr>
        <p:blipFill rotWithShape="1">
          <a:blip r:embed="rId12" cstate="email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52460" y="3962890"/>
            <a:ext cx="3566160" cy="164592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254BB2B-C61A-4B26-8279-C7A3D4A7C131}"/>
              </a:ext>
            </a:extLst>
          </p:cNvPr>
          <p:cNvSpPr txBox="1"/>
          <p:nvPr/>
        </p:nvSpPr>
        <p:spPr>
          <a:xfrm>
            <a:off x="107122" y="1605220"/>
            <a:ext cx="2851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rimer set WX317/WX315 (965bp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DD12DF-F297-4D2E-8251-126E586302EB}"/>
              </a:ext>
            </a:extLst>
          </p:cNvPr>
          <p:cNvSpPr txBox="1"/>
          <p:nvPr/>
        </p:nvSpPr>
        <p:spPr>
          <a:xfrm>
            <a:off x="1262909" y="5986186"/>
            <a:ext cx="5482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aw gel images for Fig. S2</a:t>
            </a:r>
          </a:p>
        </p:txBody>
      </p:sp>
    </p:spTree>
    <p:extLst>
      <p:ext uri="{BB962C8B-B14F-4D97-AF65-F5344CB8AC3E}">
        <p14:creationId xmlns:p14="http://schemas.microsoft.com/office/powerpoint/2010/main" val="1621390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5</TotalTime>
  <Words>583</Words>
  <Application>Microsoft Macintosh PowerPoint</Application>
  <PresentationFormat>Widescreen</PresentationFormat>
  <Paragraphs>135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WX27- Rep 1</vt:lpstr>
      <vt:lpstr>pWX27- Rep 2</vt:lpstr>
      <vt:lpstr>pWX27- Rep 3</vt:lpstr>
      <vt:lpstr>pWX68- Rep 1</vt:lpstr>
      <vt:lpstr>pWX68- Rep 2</vt:lpstr>
      <vt:lpstr>pWX68- Rep 3</vt:lpstr>
      <vt:lpstr>pWX56- Rep 1</vt:lpstr>
      <vt:lpstr>pWX56- Rep 2</vt:lpstr>
      <vt:lpstr>pWX56- Rep 3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w Gel Images For Fig. S3</dc:title>
  <dc:creator>Nitika Khatri</dc:creator>
  <cp:lastModifiedBy>Stewart, Lucy</cp:lastModifiedBy>
  <cp:revision>57</cp:revision>
  <dcterms:created xsi:type="dcterms:W3CDTF">2021-04-01T15:39:35Z</dcterms:created>
  <dcterms:modified xsi:type="dcterms:W3CDTF">2021-04-21T16:52:20Z</dcterms:modified>
</cp:coreProperties>
</file>